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14"/>
  </p:normalViewPr>
  <p:slideViewPr>
    <p:cSldViewPr snapToGrid="0" snapToObjects="1">
      <p:cViewPr varScale="1">
        <p:scale>
          <a:sx n="90" d="100"/>
          <a:sy n="90" d="100"/>
        </p:scale>
        <p:origin x="232" y="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heresa2/Desktop/Promotion/Quantitativ/Fertige%20Tabellen:Grafiken/%22Nebenthemen%22/Breastfeeding%20Reason%20&amp;%20Sensa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 sz="1400" b="0" i="0" baseline="0">
                <a:effectLst/>
              </a:rPr>
              <a:t>I'm breastfeeding because...</a:t>
            </a:r>
            <a:endParaRPr lang="de-DE" sz="1400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barChart>
        <c:barDir val="bar"/>
        <c:grouping val="percentStacked"/>
        <c:varyColors val="0"/>
        <c:ser>
          <c:idx val="0"/>
          <c:order val="0"/>
          <c:tx>
            <c:strRef>
              <c:f>'Reason for breastfeeding'!$C$1</c:f>
              <c:strCache>
                <c:ptCount val="1"/>
                <c:pt idx="0">
                  <c:v>Strongly agree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multiLvlStrRef>
              <c:f>'Reason for breastfeeding'!$A$2:$B$29</c:f>
              <c:multiLvlStrCache>
                <c:ptCount val="27"/>
                <c:lvl>
                  <c:pt idx="0">
                    <c:v>t3</c:v>
                  </c:pt>
                  <c:pt idx="1">
                    <c:v>t2</c:v>
                  </c:pt>
                  <c:pt idx="2">
                    <c:v>t1</c:v>
                  </c:pt>
                  <c:pt idx="4">
                    <c:v>t3</c:v>
                  </c:pt>
                  <c:pt idx="5">
                    <c:v>t2</c:v>
                  </c:pt>
                  <c:pt idx="6">
                    <c:v>t1</c:v>
                  </c:pt>
                  <c:pt idx="8">
                    <c:v>t3</c:v>
                  </c:pt>
                  <c:pt idx="9">
                    <c:v>t2</c:v>
                  </c:pt>
                  <c:pt idx="10">
                    <c:v>t1</c:v>
                  </c:pt>
                  <c:pt idx="12">
                    <c:v>t3</c:v>
                  </c:pt>
                  <c:pt idx="13">
                    <c:v>t2</c:v>
                  </c:pt>
                  <c:pt idx="14">
                    <c:v>t1</c:v>
                  </c:pt>
                  <c:pt idx="16">
                    <c:v>t3</c:v>
                  </c:pt>
                  <c:pt idx="17">
                    <c:v>t2</c:v>
                  </c:pt>
                  <c:pt idx="18">
                    <c:v>t1</c:v>
                  </c:pt>
                  <c:pt idx="20">
                    <c:v>t3</c:v>
                  </c:pt>
                  <c:pt idx="21">
                    <c:v>t2</c:v>
                  </c:pt>
                  <c:pt idx="22">
                    <c:v>t1</c:v>
                  </c:pt>
                  <c:pt idx="24">
                    <c:v>t3</c:v>
                  </c:pt>
                  <c:pt idx="25">
                    <c:v>t2</c:v>
                  </c:pt>
                  <c:pt idx="26">
                    <c:v>t1</c:v>
                  </c:pt>
                </c:lvl>
                <c:lvl>
                  <c:pt idx="0">
                    <c:v>Good rhythm between child and mother</c:v>
                  </c:pt>
                  <c:pt idx="4">
                    <c:v>Cheaper</c:v>
                  </c:pt>
                  <c:pt idx="8">
                    <c:v>Practical</c:v>
                  </c:pt>
                  <c:pt idx="12">
                    <c:v>Supporting mother's health</c:v>
                  </c:pt>
                  <c:pt idx="16">
                    <c:v>Supporting child's health</c:v>
                  </c:pt>
                  <c:pt idx="20">
                    <c:v>Strengthening the bond</c:v>
                  </c:pt>
                  <c:pt idx="24">
                    <c:v>Natural nutrition</c:v>
                  </c:pt>
                </c:lvl>
              </c:multiLvlStrCache>
            </c:multiLvlStrRef>
          </c:cat>
          <c:val>
            <c:numRef>
              <c:f>'Reason for breastfeeding'!$C$2:$C$28</c:f>
              <c:numCache>
                <c:formatCode>0.0%</c:formatCode>
                <c:ptCount val="27"/>
                <c:pt idx="0">
                  <c:v>0.47199999999999998</c:v>
                </c:pt>
                <c:pt idx="1">
                  <c:v>0.49199999999999999</c:v>
                </c:pt>
                <c:pt idx="2">
                  <c:v>0.28780487804878047</c:v>
                </c:pt>
                <c:pt idx="4">
                  <c:v>0.24199999999999999</c:v>
                </c:pt>
                <c:pt idx="5">
                  <c:v>0.28699999999999998</c:v>
                </c:pt>
                <c:pt idx="6">
                  <c:v>0.26108374384236455</c:v>
                </c:pt>
                <c:pt idx="8">
                  <c:v>0.60899999999999999</c:v>
                </c:pt>
                <c:pt idx="9">
                  <c:v>0.60199999999999998</c:v>
                </c:pt>
                <c:pt idx="10">
                  <c:v>0.4975609756097561</c:v>
                </c:pt>
                <c:pt idx="12">
                  <c:v>0.22700000000000001</c:v>
                </c:pt>
                <c:pt idx="13">
                  <c:v>0.26500000000000001</c:v>
                </c:pt>
                <c:pt idx="14">
                  <c:v>0.24509803921568626</c:v>
                </c:pt>
                <c:pt idx="16">
                  <c:v>0.82</c:v>
                </c:pt>
                <c:pt idx="17">
                  <c:v>0.91200000000000003</c:v>
                </c:pt>
                <c:pt idx="18">
                  <c:v>0.94146341463414629</c:v>
                </c:pt>
                <c:pt idx="20">
                  <c:v>0.72699999999999998</c:v>
                </c:pt>
                <c:pt idx="21">
                  <c:v>0.68700000000000006</c:v>
                </c:pt>
                <c:pt idx="22">
                  <c:v>0.67317073170731712</c:v>
                </c:pt>
                <c:pt idx="24">
                  <c:v>0.70299999999999996</c:v>
                </c:pt>
                <c:pt idx="25">
                  <c:v>0.82299999999999995</c:v>
                </c:pt>
                <c:pt idx="26">
                  <c:v>0.873170731707317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9C6-5E43-8904-73451AA12980}"/>
            </c:ext>
          </c:extLst>
        </c:ser>
        <c:ser>
          <c:idx val="1"/>
          <c:order val="1"/>
          <c:tx>
            <c:strRef>
              <c:f>'Reason for breastfeeding'!$D$1</c:f>
              <c:strCache>
                <c:ptCount val="1"/>
                <c:pt idx="0">
                  <c:v>Agree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Reason for breastfeeding'!$A$2:$B$29</c:f>
              <c:multiLvlStrCache>
                <c:ptCount val="27"/>
                <c:lvl>
                  <c:pt idx="0">
                    <c:v>t3</c:v>
                  </c:pt>
                  <c:pt idx="1">
                    <c:v>t2</c:v>
                  </c:pt>
                  <c:pt idx="2">
                    <c:v>t1</c:v>
                  </c:pt>
                  <c:pt idx="4">
                    <c:v>t3</c:v>
                  </c:pt>
                  <c:pt idx="5">
                    <c:v>t2</c:v>
                  </c:pt>
                  <c:pt idx="6">
                    <c:v>t1</c:v>
                  </c:pt>
                  <c:pt idx="8">
                    <c:v>t3</c:v>
                  </c:pt>
                  <c:pt idx="9">
                    <c:v>t2</c:v>
                  </c:pt>
                  <c:pt idx="10">
                    <c:v>t1</c:v>
                  </c:pt>
                  <c:pt idx="12">
                    <c:v>t3</c:v>
                  </c:pt>
                  <c:pt idx="13">
                    <c:v>t2</c:v>
                  </c:pt>
                  <c:pt idx="14">
                    <c:v>t1</c:v>
                  </c:pt>
                  <c:pt idx="16">
                    <c:v>t3</c:v>
                  </c:pt>
                  <c:pt idx="17">
                    <c:v>t2</c:v>
                  </c:pt>
                  <c:pt idx="18">
                    <c:v>t1</c:v>
                  </c:pt>
                  <c:pt idx="20">
                    <c:v>t3</c:v>
                  </c:pt>
                  <c:pt idx="21">
                    <c:v>t2</c:v>
                  </c:pt>
                  <c:pt idx="22">
                    <c:v>t1</c:v>
                  </c:pt>
                  <c:pt idx="24">
                    <c:v>t3</c:v>
                  </c:pt>
                  <c:pt idx="25">
                    <c:v>t2</c:v>
                  </c:pt>
                  <c:pt idx="26">
                    <c:v>t1</c:v>
                  </c:pt>
                </c:lvl>
                <c:lvl>
                  <c:pt idx="0">
                    <c:v>Good rhythm between child and mother</c:v>
                  </c:pt>
                  <c:pt idx="4">
                    <c:v>Cheaper</c:v>
                  </c:pt>
                  <c:pt idx="8">
                    <c:v>Practical</c:v>
                  </c:pt>
                  <c:pt idx="12">
                    <c:v>Supporting mother's health</c:v>
                  </c:pt>
                  <c:pt idx="16">
                    <c:v>Supporting child's health</c:v>
                  </c:pt>
                  <c:pt idx="20">
                    <c:v>Strengthening the bond</c:v>
                  </c:pt>
                  <c:pt idx="24">
                    <c:v>Natural nutrition</c:v>
                  </c:pt>
                </c:lvl>
              </c:multiLvlStrCache>
            </c:multiLvlStrRef>
          </c:cat>
          <c:val>
            <c:numRef>
              <c:f>'Reason for breastfeeding'!$D$2:$D$28</c:f>
              <c:numCache>
                <c:formatCode>0.0%</c:formatCode>
                <c:ptCount val="27"/>
                <c:pt idx="0">
                  <c:v>0.38600000000000001</c:v>
                </c:pt>
                <c:pt idx="1">
                  <c:v>0.35399999999999998</c:v>
                </c:pt>
                <c:pt idx="2">
                  <c:v>0.4</c:v>
                </c:pt>
                <c:pt idx="4">
                  <c:v>0.219</c:v>
                </c:pt>
                <c:pt idx="5">
                  <c:v>0.221</c:v>
                </c:pt>
                <c:pt idx="6">
                  <c:v>0.20689655172413793</c:v>
                </c:pt>
                <c:pt idx="8">
                  <c:v>0.219</c:v>
                </c:pt>
                <c:pt idx="9">
                  <c:v>0.20399999999999999</c:v>
                </c:pt>
                <c:pt idx="10">
                  <c:v>0.24878048780487805</c:v>
                </c:pt>
                <c:pt idx="12">
                  <c:v>0.313</c:v>
                </c:pt>
                <c:pt idx="13">
                  <c:v>0.34799999999999998</c:v>
                </c:pt>
                <c:pt idx="14">
                  <c:v>0.31372549019607843</c:v>
                </c:pt>
                <c:pt idx="16">
                  <c:v>0.16400000000000001</c:v>
                </c:pt>
                <c:pt idx="17">
                  <c:v>8.3000000000000004E-2</c:v>
                </c:pt>
                <c:pt idx="18">
                  <c:v>5.8536585365853662E-2</c:v>
                </c:pt>
                <c:pt idx="20">
                  <c:v>0.20300000000000001</c:v>
                </c:pt>
                <c:pt idx="21">
                  <c:v>0.214</c:v>
                </c:pt>
                <c:pt idx="22">
                  <c:v>0.20487804878048779</c:v>
                </c:pt>
                <c:pt idx="24">
                  <c:v>0.23400000000000001</c:v>
                </c:pt>
                <c:pt idx="25">
                  <c:v>0.16</c:v>
                </c:pt>
                <c:pt idx="26">
                  <c:v>0.10243902439024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9C6-5E43-8904-73451AA12980}"/>
            </c:ext>
          </c:extLst>
        </c:ser>
        <c:ser>
          <c:idx val="2"/>
          <c:order val="2"/>
          <c:tx>
            <c:strRef>
              <c:f>'Reason for breastfeeding'!$E$1</c:f>
              <c:strCache>
                <c:ptCount val="1"/>
                <c:pt idx="0">
                  <c:v>Neither agree nor disagree</c:v>
                </c:pt>
              </c:strCache>
            </c:strRef>
          </c:tx>
          <c:spPr>
            <a:solidFill>
              <a:schemeClr val="accent4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multiLvlStrRef>
              <c:f>'Reason for breastfeeding'!$A$2:$B$29</c:f>
              <c:multiLvlStrCache>
                <c:ptCount val="27"/>
                <c:lvl>
                  <c:pt idx="0">
                    <c:v>t3</c:v>
                  </c:pt>
                  <c:pt idx="1">
                    <c:v>t2</c:v>
                  </c:pt>
                  <c:pt idx="2">
                    <c:v>t1</c:v>
                  </c:pt>
                  <c:pt idx="4">
                    <c:v>t3</c:v>
                  </c:pt>
                  <c:pt idx="5">
                    <c:v>t2</c:v>
                  </c:pt>
                  <c:pt idx="6">
                    <c:v>t1</c:v>
                  </c:pt>
                  <c:pt idx="8">
                    <c:v>t3</c:v>
                  </c:pt>
                  <c:pt idx="9">
                    <c:v>t2</c:v>
                  </c:pt>
                  <c:pt idx="10">
                    <c:v>t1</c:v>
                  </c:pt>
                  <c:pt idx="12">
                    <c:v>t3</c:v>
                  </c:pt>
                  <c:pt idx="13">
                    <c:v>t2</c:v>
                  </c:pt>
                  <c:pt idx="14">
                    <c:v>t1</c:v>
                  </c:pt>
                  <c:pt idx="16">
                    <c:v>t3</c:v>
                  </c:pt>
                  <c:pt idx="17">
                    <c:v>t2</c:v>
                  </c:pt>
                  <c:pt idx="18">
                    <c:v>t1</c:v>
                  </c:pt>
                  <c:pt idx="20">
                    <c:v>t3</c:v>
                  </c:pt>
                  <c:pt idx="21">
                    <c:v>t2</c:v>
                  </c:pt>
                  <c:pt idx="22">
                    <c:v>t1</c:v>
                  </c:pt>
                  <c:pt idx="24">
                    <c:v>t3</c:v>
                  </c:pt>
                  <c:pt idx="25">
                    <c:v>t2</c:v>
                  </c:pt>
                  <c:pt idx="26">
                    <c:v>t1</c:v>
                  </c:pt>
                </c:lvl>
                <c:lvl>
                  <c:pt idx="0">
                    <c:v>Good rhythm between child and mother</c:v>
                  </c:pt>
                  <c:pt idx="4">
                    <c:v>Cheaper</c:v>
                  </c:pt>
                  <c:pt idx="8">
                    <c:v>Practical</c:v>
                  </c:pt>
                  <c:pt idx="12">
                    <c:v>Supporting mother's health</c:v>
                  </c:pt>
                  <c:pt idx="16">
                    <c:v>Supporting child's health</c:v>
                  </c:pt>
                  <c:pt idx="20">
                    <c:v>Strengthening the bond</c:v>
                  </c:pt>
                  <c:pt idx="24">
                    <c:v>Natural nutrition</c:v>
                  </c:pt>
                </c:lvl>
              </c:multiLvlStrCache>
            </c:multiLvlStrRef>
          </c:cat>
          <c:val>
            <c:numRef>
              <c:f>'Reason for breastfeeding'!$E$2:$E$28</c:f>
              <c:numCache>
                <c:formatCode>0.0%</c:formatCode>
                <c:ptCount val="27"/>
                <c:pt idx="0">
                  <c:v>0.13400000000000001</c:v>
                </c:pt>
                <c:pt idx="1">
                  <c:v>0.13300000000000001</c:v>
                </c:pt>
                <c:pt idx="2">
                  <c:v>0.24878048780487805</c:v>
                </c:pt>
                <c:pt idx="4">
                  <c:v>0.18</c:v>
                </c:pt>
                <c:pt idx="5">
                  <c:v>0.182</c:v>
                </c:pt>
                <c:pt idx="6">
                  <c:v>0.15270935960591134</c:v>
                </c:pt>
                <c:pt idx="8">
                  <c:v>0.10199999999999999</c:v>
                </c:pt>
                <c:pt idx="9">
                  <c:v>0.16600000000000001</c:v>
                </c:pt>
                <c:pt idx="10">
                  <c:v>0.16585365853658537</c:v>
                </c:pt>
                <c:pt idx="12">
                  <c:v>0.33600000000000002</c:v>
                </c:pt>
                <c:pt idx="13">
                  <c:v>0.28699999999999998</c:v>
                </c:pt>
                <c:pt idx="14">
                  <c:v>0.27450980392156865</c:v>
                </c:pt>
                <c:pt idx="16">
                  <c:v>1.6E-2</c:v>
                </c:pt>
                <c:pt idx="17">
                  <c:v>6.0000000000000001E-3</c:v>
                </c:pt>
                <c:pt idx="18">
                  <c:v>0</c:v>
                </c:pt>
                <c:pt idx="20">
                  <c:v>5.5E-2</c:v>
                </c:pt>
                <c:pt idx="21">
                  <c:v>7.6999999999999999E-2</c:v>
                </c:pt>
                <c:pt idx="22">
                  <c:v>7.8048780487804878E-2</c:v>
                </c:pt>
                <c:pt idx="24">
                  <c:v>6.3E-2</c:v>
                </c:pt>
                <c:pt idx="25">
                  <c:v>1.7000000000000001E-2</c:v>
                </c:pt>
                <c:pt idx="26">
                  <c:v>1.463414634146341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9C6-5E43-8904-73451AA12980}"/>
            </c:ext>
          </c:extLst>
        </c:ser>
        <c:ser>
          <c:idx val="3"/>
          <c:order val="3"/>
          <c:tx>
            <c:strRef>
              <c:f>'Reason for breastfeeding'!$F$1</c:f>
              <c:strCache>
                <c:ptCount val="1"/>
                <c:pt idx="0">
                  <c:v>Disagree</c:v>
                </c:pt>
              </c:strCache>
            </c:strRef>
          </c:tx>
          <c:spPr>
            <a:solidFill>
              <a:srgbClr val="C00000">
                <a:alpha val="50000"/>
              </a:srgbClr>
            </a:solidFill>
            <a:ln>
              <a:noFill/>
            </a:ln>
            <a:effectLst/>
          </c:spPr>
          <c:invertIfNegative val="0"/>
          <c:cat>
            <c:multiLvlStrRef>
              <c:f>'Reason for breastfeeding'!$A$2:$B$29</c:f>
              <c:multiLvlStrCache>
                <c:ptCount val="27"/>
                <c:lvl>
                  <c:pt idx="0">
                    <c:v>t3</c:v>
                  </c:pt>
                  <c:pt idx="1">
                    <c:v>t2</c:v>
                  </c:pt>
                  <c:pt idx="2">
                    <c:v>t1</c:v>
                  </c:pt>
                  <c:pt idx="4">
                    <c:v>t3</c:v>
                  </c:pt>
                  <c:pt idx="5">
                    <c:v>t2</c:v>
                  </c:pt>
                  <c:pt idx="6">
                    <c:v>t1</c:v>
                  </c:pt>
                  <c:pt idx="8">
                    <c:v>t3</c:v>
                  </c:pt>
                  <c:pt idx="9">
                    <c:v>t2</c:v>
                  </c:pt>
                  <c:pt idx="10">
                    <c:v>t1</c:v>
                  </c:pt>
                  <c:pt idx="12">
                    <c:v>t3</c:v>
                  </c:pt>
                  <c:pt idx="13">
                    <c:v>t2</c:v>
                  </c:pt>
                  <c:pt idx="14">
                    <c:v>t1</c:v>
                  </c:pt>
                  <c:pt idx="16">
                    <c:v>t3</c:v>
                  </c:pt>
                  <c:pt idx="17">
                    <c:v>t2</c:v>
                  </c:pt>
                  <c:pt idx="18">
                    <c:v>t1</c:v>
                  </c:pt>
                  <c:pt idx="20">
                    <c:v>t3</c:v>
                  </c:pt>
                  <c:pt idx="21">
                    <c:v>t2</c:v>
                  </c:pt>
                  <c:pt idx="22">
                    <c:v>t1</c:v>
                  </c:pt>
                  <c:pt idx="24">
                    <c:v>t3</c:v>
                  </c:pt>
                  <c:pt idx="25">
                    <c:v>t2</c:v>
                  </c:pt>
                  <c:pt idx="26">
                    <c:v>t1</c:v>
                  </c:pt>
                </c:lvl>
                <c:lvl>
                  <c:pt idx="0">
                    <c:v>Good rhythm between child and mother</c:v>
                  </c:pt>
                  <c:pt idx="4">
                    <c:v>Cheaper</c:v>
                  </c:pt>
                  <c:pt idx="8">
                    <c:v>Practical</c:v>
                  </c:pt>
                  <c:pt idx="12">
                    <c:v>Supporting mother's health</c:v>
                  </c:pt>
                  <c:pt idx="16">
                    <c:v>Supporting child's health</c:v>
                  </c:pt>
                  <c:pt idx="20">
                    <c:v>Strengthening the bond</c:v>
                  </c:pt>
                  <c:pt idx="24">
                    <c:v>Natural nutrition</c:v>
                  </c:pt>
                </c:lvl>
              </c:multiLvlStrCache>
            </c:multiLvlStrRef>
          </c:cat>
          <c:val>
            <c:numRef>
              <c:f>'Reason for breastfeeding'!$F$2:$F$28</c:f>
              <c:numCache>
                <c:formatCode>0.0%</c:formatCode>
                <c:ptCount val="27"/>
                <c:pt idx="0">
                  <c:v>8.0000000000000002E-3</c:v>
                </c:pt>
                <c:pt idx="1">
                  <c:v>1.7000000000000001E-2</c:v>
                </c:pt>
                <c:pt idx="2">
                  <c:v>4.3902439024390241E-2</c:v>
                </c:pt>
                <c:pt idx="4">
                  <c:v>0.20300000000000001</c:v>
                </c:pt>
                <c:pt idx="5">
                  <c:v>0.182</c:v>
                </c:pt>
                <c:pt idx="6">
                  <c:v>0.24630541871921183</c:v>
                </c:pt>
                <c:pt idx="8">
                  <c:v>3.9E-2</c:v>
                </c:pt>
                <c:pt idx="9">
                  <c:v>2.8000000000000001E-2</c:v>
                </c:pt>
                <c:pt idx="10">
                  <c:v>5.3658536585365853E-2</c:v>
                </c:pt>
                <c:pt idx="12">
                  <c:v>9.4E-2</c:v>
                </c:pt>
                <c:pt idx="13">
                  <c:v>8.3000000000000004E-2</c:v>
                </c:pt>
                <c:pt idx="14">
                  <c:v>0.13725490196078433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20">
                  <c:v>1.6E-2</c:v>
                </c:pt>
                <c:pt idx="21">
                  <c:v>2.1999999999999999E-2</c:v>
                </c:pt>
                <c:pt idx="22">
                  <c:v>4.3902439024390241E-2</c:v>
                </c:pt>
                <c:pt idx="24">
                  <c:v>0</c:v>
                </c:pt>
                <c:pt idx="25">
                  <c:v>0</c:v>
                </c:pt>
                <c:pt idx="26">
                  <c:v>4.878048780487804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9C6-5E43-8904-73451AA12980}"/>
            </c:ext>
          </c:extLst>
        </c:ser>
        <c:ser>
          <c:idx val="4"/>
          <c:order val="4"/>
          <c:tx>
            <c:strRef>
              <c:f>'Reason for breastfeeding'!$G$1</c:f>
              <c:strCache>
                <c:ptCount val="1"/>
                <c:pt idx="0">
                  <c:v>Strongly disagree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multiLvlStrRef>
              <c:f>'Reason for breastfeeding'!$A$2:$B$29</c:f>
              <c:multiLvlStrCache>
                <c:ptCount val="27"/>
                <c:lvl>
                  <c:pt idx="0">
                    <c:v>t3</c:v>
                  </c:pt>
                  <c:pt idx="1">
                    <c:v>t2</c:v>
                  </c:pt>
                  <c:pt idx="2">
                    <c:v>t1</c:v>
                  </c:pt>
                  <c:pt idx="4">
                    <c:v>t3</c:v>
                  </c:pt>
                  <c:pt idx="5">
                    <c:v>t2</c:v>
                  </c:pt>
                  <c:pt idx="6">
                    <c:v>t1</c:v>
                  </c:pt>
                  <c:pt idx="8">
                    <c:v>t3</c:v>
                  </c:pt>
                  <c:pt idx="9">
                    <c:v>t2</c:v>
                  </c:pt>
                  <c:pt idx="10">
                    <c:v>t1</c:v>
                  </c:pt>
                  <c:pt idx="12">
                    <c:v>t3</c:v>
                  </c:pt>
                  <c:pt idx="13">
                    <c:v>t2</c:v>
                  </c:pt>
                  <c:pt idx="14">
                    <c:v>t1</c:v>
                  </c:pt>
                  <c:pt idx="16">
                    <c:v>t3</c:v>
                  </c:pt>
                  <c:pt idx="17">
                    <c:v>t2</c:v>
                  </c:pt>
                  <c:pt idx="18">
                    <c:v>t1</c:v>
                  </c:pt>
                  <c:pt idx="20">
                    <c:v>t3</c:v>
                  </c:pt>
                  <c:pt idx="21">
                    <c:v>t2</c:v>
                  </c:pt>
                  <c:pt idx="22">
                    <c:v>t1</c:v>
                  </c:pt>
                  <c:pt idx="24">
                    <c:v>t3</c:v>
                  </c:pt>
                  <c:pt idx="25">
                    <c:v>t2</c:v>
                  </c:pt>
                  <c:pt idx="26">
                    <c:v>t1</c:v>
                  </c:pt>
                </c:lvl>
                <c:lvl>
                  <c:pt idx="0">
                    <c:v>Good rhythm between child and mother</c:v>
                  </c:pt>
                  <c:pt idx="4">
                    <c:v>Cheaper</c:v>
                  </c:pt>
                  <c:pt idx="8">
                    <c:v>Practical</c:v>
                  </c:pt>
                  <c:pt idx="12">
                    <c:v>Supporting mother's health</c:v>
                  </c:pt>
                  <c:pt idx="16">
                    <c:v>Supporting child's health</c:v>
                  </c:pt>
                  <c:pt idx="20">
                    <c:v>Strengthening the bond</c:v>
                  </c:pt>
                  <c:pt idx="24">
                    <c:v>Natural nutrition</c:v>
                  </c:pt>
                </c:lvl>
              </c:multiLvlStrCache>
            </c:multiLvlStrRef>
          </c:cat>
          <c:val>
            <c:numRef>
              <c:f>'Reason for breastfeeding'!$G$2:$G$28</c:f>
              <c:numCache>
                <c:formatCode>0.0%</c:formatCode>
                <c:ptCount val="27"/>
                <c:pt idx="0">
                  <c:v>0</c:v>
                </c:pt>
                <c:pt idx="1">
                  <c:v>6.0000000000000001E-3</c:v>
                </c:pt>
                <c:pt idx="2">
                  <c:v>1.9512195121951219E-2</c:v>
                </c:pt>
                <c:pt idx="4">
                  <c:v>0.156</c:v>
                </c:pt>
                <c:pt idx="5">
                  <c:v>0.127</c:v>
                </c:pt>
                <c:pt idx="6">
                  <c:v>0.13300492610837439</c:v>
                </c:pt>
                <c:pt idx="8">
                  <c:v>3.1E-2</c:v>
                </c:pt>
                <c:pt idx="9">
                  <c:v>0</c:v>
                </c:pt>
                <c:pt idx="10">
                  <c:v>3.4146341463414637E-2</c:v>
                </c:pt>
                <c:pt idx="12">
                  <c:v>3.1E-2</c:v>
                </c:pt>
                <c:pt idx="13">
                  <c:v>1.7000000000000001E-2</c:v>
                </c:pt>
                <c:pt idx="14">
                  <c:v>2.9411764705882353E-2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4.878048780487804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9C6-5E43-8904-73451AA1298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101378127"/>
        <c:axId val="2101823231"/>
      </c:barChart>
      <c:catAx>
        <c:axId val="2101378127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01823231"/>
        <c:crosses val="autoZero"/>
        <c:auto val="1"/>
        <c:lblAlgn val="ctr"/>
        <c:lblOffset val="100"/>
        <c:noMultiLvlLbl val="0"/>
      </c:catAx>
      <c:valAx>
        <c:axId val="2101823231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210137812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A65B214-CBC1-534A-B5BA-5D4CE29EB45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0665C911-53D2-E745-AE81-5E6F6E59570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E949FF3-9F18-FF46-AEAF-0A4F1488B8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C2BCC-4586-644E-960E-B39E153823A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3C5A7CA-582A-354B-A693-92837F7623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F7B62E1-1936-A140-8037-728C588FA8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014AA-218E-444B-AA1B-58D53DA924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96697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C919CAA-9216-B14A-AD1A-D4AE05B42E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DB6B136C-FC98-F74C-B5B8-FFC2885A0B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2407D47F-A390-D046-8995-35909A923F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C2BCC-4586-644E-960E-B39E153823A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5936F70-DDF0-0643-85C2-FF3A45575A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5D850D0-3B0B-234D-B327-E2F3FCD8F5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014AA-218E-444B-AA1B-58D53DA924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478629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31D50185-5DB3-6C4D-834C-F219C03AE58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664EFEE6-3703-6644-B9BC-42469BAE18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4E1EABD-995B-A94C-ADA8-959904DE3F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C2BCC-4586-644E-960E-B39E153823A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0ECB552-25FE-EE47-B7B0-BB5096E9EF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A0CA023-7A6A-BB4E-8EBC-531C8D38C4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014AA-218E-444B-AA1B-58D53DA924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8776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EA6F303-8A8E-3946-825A-19561016B9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79E7795-1070-2141-9E28-5E2489BE75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98E9226-1039-7047-8079-F2956012CD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C2BCC-4586-644E-960E-B39E153823A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FE630BD-F33A-CA41-AE8F-C60F04A107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1FDFCDC-4643-5341-AE1C-95D70B38B8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014AA-218E-444B-AA1B-58D53DA924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7393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D63896C-759B-624C-9DF5-2EAF86AA09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77E597F-EC4E-004C-B082-C0EDA048A1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2F36CB3-A465-7345-AFC0-FB264FEF1D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C2BCC-4586-644E-960E-B39E153823A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B5B8148-C7EF-0C49-8DB8-2AFDA61B05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FDACEE5-C752-A64C-91C5-B8C6AC118F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014AA-218E-444B-AA1B-58D53DA924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5747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FBE7194-48CA-0E4B-8EB2-9C29B7A998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A44403F-0ADD-D94D-85CB-BD59F08C46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0D6FA62E-3329-FC41-A788-16153998BB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CC1A03F-E36B-D54E-B7AA-BEACFED42B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C2BCC-4586-644E-960E-B39E153823A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DECE8B87-C59C-EB4D-9D33-84C64D7E5D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7AD09AF-6AA7-0349-BFB6-17F10DF2F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014AA-218E-444B-AA1B-58D53DA924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62253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B1EA1A3-4AE0-1849-802C-45F689820A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34B1F3D-9AE5-A947-81B6-963370E3C0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54FF5B31-9198-4D4C-B92A-176F9DF213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0146AB41-488E-1E46-B326-D3FAA6BAAD0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BB078DEA-A6C9-8E48-B424-052C08F00DD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643D06DC-CA09-D347-96BE-4E291C62E0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C2BCC-4586-644E-960E-B39E153823A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6C9611C1-ED96-174E-BCA9-B41034049C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7F716334-B8BC-7847-8635-E9E9E5606C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014AA-218E-444B-AA1B-58D53DA924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1983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3B12824-D761-F849-BFA9-29D4116738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E4433534-74E6-B24C-A8DF-0C8367E6C8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C2BCC-4586-644E-960E-B39E153823A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4379BFCB-489E-F74C-ABE3-A1CD66B686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A18E8F08-431D-844D-99FB-135EDDA5B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014AA-218E-444B-AA1B-58D53DA924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78301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2182A969-73B3-2C44-A5D8-62F94FFEFF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C2BCC-4586-644E-960E-B39E153823A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3BF7426B-9397-CE47-8CA2-0751592DF7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CF94740C-4770-DA4F-92E1-4D20505472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014AA-218E-444B-AA1B-58D53DA924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696173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68B1B7D-F2A2-C84D-868E-84F0F5747A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BBE406C-2C8D-F742-A7E1-9DAEAE5021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B48E0E2-7736-9A4A-8020-A97E0E37A3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5D981D38-2E5C-8144-BA3B-28465DB495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C2BCC-4586-644E-960E-B39E153823A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52A38B52-5CE4-5948-A29A-7BF99E4131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0290317-6707-C94E-BF9A-B9B74B8E15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014AA-218E-444B-AA1B-58D53DA924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88951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147E1F7-F659-2243-B810-126841E9A0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7E0FF7EB-4B2C-9A40-A1C7-85460AC651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2B25B774-11D9-9D49-81AF-4838CBB770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E7DD0A7-5EEE-2147-8AF7-1ECDC59342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8C2BCC-4586-644E-960E-B39E153823A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7066DAF-7E4C-7240-858C-144A9D1E6B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7FCE340-7725-234D-8D31-153E206957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5014AA-218E-444B-AA1B-58D53DA924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24291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5B0C90AC-684A-C843-AD1D-FB1440402C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99B5FBC7-0578-8046-9CB7-A6FF0E4C46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775BDB7-3D35-BE43-ACF2-A598BBDBCC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8C2BCC-4586-644E-960E-B39E153823A9}" type="datetimeFigureOut">
              <a:rPr lang="de-DE" smtClean="0"/>
              <a:t>30.03.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1CA9620-78E7-D546-ABD7-A5469AF99E1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BC47ED4-14A3-AD4B-A880-B6872C7551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5014AA-218E-444B-AA1B-58D53DA9249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342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Inhaltsplatzhalter 3">
            <a:extLst>
              <a:ext uri="{FF2B5EF4-FFF2-40B4-BE49-F238E27FC236}">
                <a16:creationId xmlns:a16="http://schemas.microsoft.com/office/drawing/2014/main" id="{550BC4C0-D1EC-2344-9C9A-A018152D7CB2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942738806"/>
              </p:ext>
            </p:extLst>
          </p:nvPr>
        </p:nvGraphicFramePr>
        <p:xfrm>
          <a:off x="838200" y="278606"/>
          <a:ext cx="10515600" cy="63007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1781976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</Words>
  <Application>Microsoft Macintosh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Ertlmaier, Theresa Philomena</dc:creator>
  <cp:lastModifiedBy>Ertlmaier, Theresa Philomena</cp:lastModifiedBy>
  <cp:revision>1</cp:revision>
  <dcterms:created xsi:type="dcterms:W3CDTF">2025-03-30T15:23:22Z</dcterms:created>
  <dcterms:modified xsi:type="dcterms:W3CDTF">2025-03-30T15:24:11Z</dcterms:modified>
</cp:coreProperties>
</file>